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398"/>
    <p:restoredTop sz="94694"/>
  </p:normalViewPr>
  <p:slideViewPr>
    <p:cSldViewPr snapToGrid="0">
      <p:cViewPr varScale="1">
        <p:scale>
          <a:sx n="79" d="100"/>
          <a:sy n="79" d="100"/>
        </p:scale>
        <p:origin x="108" y="6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CCEEDAF5-0C4E-6C9A-F3E5-E82F9588A31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xmlns="" id="{E99E7D38-DCD0-D50E-817E-EE6275A3E0C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31A591B6-77D3-EC1B-86BD-B8E567DD29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05AE9-435B-5243-886C-8F72967B3C67}" type="datetimeFigureOut">
              <a:rPr lang="de-DE" smtClean="0"/>
              <a:t>04.10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BEFDAE7D-F67A-05D6-1949-7921183A59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AC8CFB1E-6399-C86B-9134-7C9229FB74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54B1C0-B702-4B44-94F5-16AEA9910DD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948284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6624CE71-3C1B-2E51-921D-F51042F7C4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xmlns="" id="{E3954D99-E885-EECF-017C-82F7153DE32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639862E0-1612-77C0-456A-327F9F2F20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05AE9-435B-5243-886C-8F72967B3C67}" type="datetimeFigureOut">
              <a:rPr lang="de-DE" smtClean="0"/>
              <a:t>04.10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89745864-4088-7332-1857-8D93713945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EF0E3D49-FB29-F538-DED2-7A46A516AC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54B1C0-B702-4B44-94F5-16AEA9910DD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218123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xmlns="" id="{33ACB577-1576-3D5B-094D-2642427D178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xmlns="" id="{429B2A7D-959B-10F7-EEEE-1A93D7A9DD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2750F966-95DF-3D53-C494-CD3018A6FB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05AE9-435B-5243-886C-8F72967B3C67}" type="datetimeFigureOut">
              <a:rPr lang="de-DE" smtClean="0"/>
              <a:t>04.10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A1DDEB35-5EF3-4BF1-4B0A-8B0945F010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F2C8D182-B44C-1FAE-19E5-70C9C3CDF4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54B1C0-B702-4B44-94F5-16AEA9910DD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256593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30577DE7-94FC-4F5B-F6C3-DC44B559BF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xmlns="" id="{A4FBDFD5-B545-B2D6-7CCF-828E9BCFECF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55B0AD74-CF9E-21AB-8BFF-D063EA28F3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05AE9-435B-5243-886C-8F72967B3C67}" type="datetimeFigureOut">
              <a:rPr lang="de-DE" smtClean="0"/>
              <a:t>04.10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EA922E39-0EF0-B75F-4A0F-AE83C93F65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3343CE6E-5AF6-D49F-CAA6-071D7745B2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54B1C0-B702-4B44-94F5-16AEA9910DD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427657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ED5234FF-E5FE-8650-3393-55D6B62852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xmlns="" id="{743C22E2-BD40-4860-D24A-DEDB21C012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C8682711-2D69-1F7A-2310-1045E04ABC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05AE9-435B-5243-886C-8F72967B3C67}" type="datetimeFigureOut">
              <a:rPr lang="de-DE" smtClean="0"/>
              <a:t>04.10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B3A089D6-BC5F-318C-9D4A-144A80CFFC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0E485E46-5317-C81F-8147-B3954A99FE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54B1C0-B702-4B44-94F5-16AEA9910DD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014931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58CCD66C-0048-837B-50E8-90BBCBD2A0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xmlns="" id="{6FE70465-C1E9-6C26-4C78-076EE6DC02A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xmlns="" id="{1316316E-A937-C087-2ADB-A295FCCFF4B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xmlns="" id="{43BEAFD9-4E4E-F3E5-EEB1-5C54C2E02A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05AE9-435B-5243-886C-8F72967B3C67}" type="datetimeFigureOut">
              <a:rPr lang="de-DE" smtClean="0"/>
              <a:t>04.10.20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xmlns="" id="{2523CF03-1FF0-F095-AD83-17571549C8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xmlns="" id="{BF8B0B64-A3BB-4AD8-D3E2-91B0ECC2C3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54B1C0-B702-4B44-94F5-16AEA9910DD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648777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FF64FD95-8F64-A185-77A1-E80ECEB5D6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xmlns="" id="{81E17667-CC80-0721-46F2-AAC15296DA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xmlns="" id="{8AB05E6E-1BD2-306A-F8FF-8DC8DC5F598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xmlns="" id="{728C542A-4681-E9F0-E8D1-2763BC1EC8D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xmlns="" id="{50D8EE82-793A-7F18-E549-2BFD4120466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xmlns="" id="{FB7A0468-26F0-31C6-1B0F-0C34638CED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05AE9-435B-5243-886C-8F72967B3C67}" type="datetimeFigureOut">
              <a:rPr lang="de-DE" smtClean="0"/>
              <a:t>04.10.2024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xmlns="" id="{B6EDDF08-FC45-3AAF-E0A5-15C5CE364F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xmlns="" id="{FC92DBD4-7465-FC19-301D-B5B3062838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54B1C0-B702-4B44-94F5-16AEA9910DD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15886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FFF92655-758A-61AC-E04F-7968E03F72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xmlns="" id="{F733DA1A-40DE-56D7-2181-1362D77D26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05AE9-435B-5243-886C-8F72967B3C67}" type="datetimeFigureOut">
              <a:rPr lang="de-DE" smtClean="0"/>
              <a:t>04.10.2024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xmlns="" id="{E874DCA2-C209-6FC0-71F3-65A84493D8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xmlns="" id="{39082A40-AB29-F6BF-D455-C70F5861E1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54B1C0-B702-4B44-94F5-16AEA9910DD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489040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xmlns="" id="{85C032C3-5347-D9EF-8D95-453E8D814D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05AE9-435B-5243-886C-8F72967B3C67}" type="datetimeFigureOut">
              <a:rPr lang="de-DE" smtClean="0"/>
              <a:t>04.10.2024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xmlns="" id="{95D3300C-12F5-E557-1E22-C4100377EA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xmlns="" id="{13B4490F-DB21-DC56-4716-99DE8E4DA1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54B1C0-B702-4B44-94F5-16AEA9910DD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46738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4FAC1628-CC42-D442-0E60-077D581F73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xmlns="" id="{5237FBBF-D3F5-9673-7367-09AFBF46F23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xmlns="" id="{37BF8C3A-1EEA-B2D7-9949-80E045B160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xmlns="" id="{D8B5B9CE-E0D3-FD63-11CB-F07D828D92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05AE9-435B-5243-886C-8F72967B3C67}" type="datetimeFigureOut">
              <a:rPr lang="de-DE" smtClean="0"/>
              <a:t>04.10.20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xmlns="" id="{38475F07-1CFB-5D39-446C-923B86B904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xmlns="" id="{05EA48B2-66FD-4C11-B682-50718E5A98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54B1C0-B702-4B44-94F5-16AEA9910DD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333685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2295A9C1-4465-DB89-42F0-A7231C4F6E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xmlns="" id="{014D36C0-8608-D01B-3D6B-298ACF47073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xmlns="" id="{B22A95F9-B870-1004-A74A-8B56631218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xmlns="" id="{BBF39318-45A1-89DA-25F8-DC2C98940D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05AE9-435B-5243-886C-8F72967B3C67}" type="datetimeFigureOut">
              <a:rPr lang="de-DE" smtClean="0"/>
              <a:t>04.10.20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xmlns="" id="{1ACC4F70-4669-944D-CFB9-67AB85CD6E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xmlns="" id="{554265F7-7B95-449E-F66B-54EBCDA843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54B1C0-B702-4B44-94F5-16AEA9910DD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600181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xmlns="" id="{7ADA447F-4AAE-A640-4AF8-7C68EF5320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xmlns="" id="{3BADC8E9-7857-4452-503F-DB0F9DAC5B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4929CC4B-912F-B0C1-C713-8DB04300C40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4E05AE9-435B-5243-886C-8F72967B3C67}" type="datetimeFigureOut">
              <a:rPr lang="de-DE" smtClean="0"/>
              <a:t>04.10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EF4627C6-0D99-8C09-27AE-4CB4B61C7D2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F8E0F266-2D50-C04F-CA26-CF1966E1D5E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354B1C0-B702-4B44-94F5-16AEA9910DD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072491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Grafik 9">
            <a:extLst>
              <a:ext uri="{FF2B5EF4-FFF2-40B4-BE49-F238E27FC236}">
                <a16:creationId xmlns:a16="http://schemas.microsoft.com/office/drawing/2014/main" xmlns="" id="{D9570F35-8035-C2D4-5FF8-9FDFB4E88D05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0815" t="8746" r="11665"/>
          <a:stretch/>
        </p:blipFill>
        <p:spPr>
          <a:xfrm>
            <a:off x="1890774" y="265873"/>
            <a:ext cx="4777562" cy="5624006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xmlns="" id="{2852813C-084C-FE51-EDAD-67F1DF4BCDE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9918" t="10344" r="46974" b="83800"/>
          <a:stretch/>
        </p:blipFill>
        <p:spPr>
          <a:xfrm>
            <a:off x="6803178" y="335833"/>
            <a:ext cx="1816445" cy="401595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xmlns="" id="{498B08CF-E0A1-4B53-3907-E8DAEBE8E2E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3264" t="11545" r="28350" b="83800"/>
          <a:stretch/>
        </p:blipFill>
        <p:spPr>
          <a:xfrm>
            <a:off x="6956261" y="790779"/>
            <a:ext cx="1008743" cy="319216"/>
          </a:xfrm>
          <a:prstGeom prst="rect">
            <a:avLst/>
          </a:prstGeom>
        </p:spPr>
      </p:pic>
      <p:sp>
        <p:nvSpPr>
          <p:cNvPr id="3" name="Textfeld 2">
            <a:extLst>
              <a:ext uri="{FF2B5EF4-FFF2-40B4-BE49-F238E27FC236}">
                <a16:creationId xmlns:a16="http://schemas.microsoft.com/office/drawing/2014/main" xmlns="" id="{ADD35F94-9818-E5AF-FE57-8D3D0E3B0C68}"/>
              </a:ext>
            </a:extLst>
          </p:cNvPr>
          <p:cNvSpPr txBox="1"/>
          <p:nvPr/>
        </p:nvSpPr>
        <p:spPr>
          <a:xfrm>
            <a:off x="199697" y="5889879"/>
            <a:ext cx="11792606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rtl="0">
              <a:spcBef>
                <a:spcPts val="0"/>
              </a:spcBef>
              <a:spcAft>
                <a:spcPts val="0"/>
              </a:spcAft>
            </a:pPr>
            <a:r>
              <a:rPr lang="de-DE" sz="1600" b="1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Supplementary</a:t>
            </a:r>
            <a:r>
              <a:rPr lang="de-DE" sz="16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Figure 1: </a:t>
            </a:r>
            <a:r>
              <a:rPr lang="de-DE" sz="1600" b="1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Overview</a:t>
            </a:r>
            <a:r>
              <a:rPr lang="de-DE" sz="16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and </a:t>
            </a:r>
            <a:r>
              <a:rPr lang="de-DE" sz="1600" b="1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results</a:t>
            </a:r>
            <a:r>
              <a:rPr lang="de-DE" sz="16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de-DE" sz="1600" b="1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of</a:t>
            </a:r>
            <a:r>
              <a:rPr lang="de-DE" sz="16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viral </a:t>
            </a:r>
            <a:r>
              <a:rPr lang="de-DE" sz="1600" b="1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metagenomic</a:t>
            </a:r>
            <a:r>
              <a:rPr lang="de-DE" sz="16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de-DE" sz="1600" b="1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sequencing</a:t>
            </a:r>
            <a:r>
              <a:rPr lang="de-DE" sz="16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de-DE" sz="1600" b="1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from</a:t>
            </a:r>
            <a:r>
              <a:rPr lang="de-DE" sz="16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non-FFPE </a:t>
            </a:r>
            <a:r>
              <a:rPr lang="de-DE" sz="1600" b="1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samples</a:t>
            </a:r>
            <a:r>
              <a:rPr lang="de-DE" sz="16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. </a:t>
            </a:r>
            <a:r>
              <a:rPr lang="de-DE" sz="16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Sample </a:t>
            </a:r>
            <a:r>
              <a:rPr lang="de-DE" sz="16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overview</a:t>
            </a:r>
            <a:r>
              <a:rPr lang="de-DE" sz="16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de-DE" sz="16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of</a:t>
            </a:r>
            <a:r>
              <a:rPr lang="de-DE" sz="16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cohort </a:t>
            </a:r>
            <a:r>
              <a:rPr lang="de-DE" sz="16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with</a:t>
            </a:r>
            <a:r>
              <a:rPr lang="de-DE" sz="16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sample type and </a:t>
            </a:r>
            <a:r>
              <a:rPr lang="de-DE" sz="16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virus</a:t>
            </a:r>
            <a:r>
              <a:rPr lang="de-DE" sz="16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de-DE" sz="16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haracteristics</a:t>
            </a:r>
            <a:r>
              <a:rPr lang="de-DE" sz="1600" dirty="0">
                <a:solidFill>
                  <a:srgbClr val="000000"/>
                </a:solidFill>
                <a:latin typeface="Calibri" panose="020F0502020204030204" pitchFamily="34" charset="0"/>
              </a:rPr>
              <a:t>,</a:t>
            </a:r>
            <a:r>
              <a:rPr lang="de-DE" sz="16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de-DE" sz="16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s</a:t>
            </a:r>
            <a:r>
              <a:rPr lang="de-DE" sz="16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de-DE" sz="16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well</a:t>
            </a:r>
            <a:r>
              <a:rPr lang="de-DE" sz="16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de-DE" sz="16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s</a:t>
            </a:r>
            <a:r>
              <a:rPr lang="de-DE" sz="16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de-DE" sz="16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nalysis</a:t>
            </a:r>
            <a:r>
              <a:rPr lang="de-DE" sz="16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de-DE" sz="16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results</a:t>
            </a:r>
            <a:r>
              <a:rPr lang="de-DE" sz="16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de-DE" sz="16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of</a:t>
            </a:r>
            <a:r>
              <a:rPr lang="de-DE" sz="16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de-DE" sz="16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direct</a:t>
            </a:r>
            <a:r>
              <a:rPr lang="de-DE" sz="16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(</a:t>
            </a:r>
            <a:r>
              <a:rPr lang="de-DE" sz="16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onventional</a:t>
            </a:r>
            <a:r>
              <a:rPr lang="de-DE" sz="16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) </a:t>
            </a:r>
            <a:r>
              <a:rPr lang="de-DE" sz="16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metagenomic</a:t>
            </a:r>
            <a:r>
              <a:rPr lang="de-DE" sz="16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de-DE" sz="16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sequencing</a:t>
            </a:r>
            <a:r>
              <a:rPr lang="de-DE" sz="16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de-DE" sz="16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ompared</a:t>
            </a:r>
            <a:r>
              <a:rPr lang="de-DE" sz="16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de-DE" sz="16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o</a:t>
            </a:r>
            <a:r>
              <a:rPr lang="de-DE" sz="16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viral </a:t>
            </a:r>
            <a:r>
              <a:rPr lang="de-DE" sz="16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panel</a:t>
            </a:r>
            <a:r>
              <a:rPr lang="de-DE" sz="16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 </a:t>
            </a:r>
            <a:r>
              <a:rPr lang="de-DE" sz="16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sequencing</a:t>
            </a:r>
            <a:r>
              <a:rPr lang="de-DE" sz="16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.</a:t>
            </a:r>
            <a:endParaRPr lang="de-DE" sz="1600" dirty="0"/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xmlns="" id="{74E92E2F-69B3-6098-D22B-05665FDF5E29}"/>
              </a:ext>
            </a:extLst>
          </p:cNvPr>
          <p:cNvSpPr txBox="1"/>
          <p:nvPr/>
        </p:nvSpPr>
        <p:spPr>
          <a:xfrm>
            <a:off x="2906176" y="1464977"/>
            <a:ext cx="5675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&lt; 5%</a:t>
            </a:r>
          </a:p>
        </p:txBody>
      </p:sp>
    </p:spTree>
    <p:extLst>
      <p:ext uri="{BB962C8B-B14F-4D97-AF65-F5344CB8AC3E}">
        <p14:creationId xmlns:p14="http://schemas.microsoft.com/office/powerpoint/2010/main" val="18415454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xmlns="" id="{ADD35F94-9818-E5AF-FE57-8D3D0E3B0C68}"/>
              </a:ext>
            </a:extLst>
          </p:cNvPr>
          <p:cNvSpPr txBox="1"/>
          <p:nvPr/>
        </p:nvSpPr>
        <p:spPr>
          <a:xfrm>
            <a:off x="199697" y="5751379"/>
            <a:ext cx="11792606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rtl="0">
              <a:spcBef>
                <a:spcPts val="0"/>
              </a:spcBef>
              <a:spcAft>
                <a:spcPts val="0"/>
              </a:spcAft>
            </a:pPr>
            <a:r>
              <a:rPr lang="de-DE" sz="1400" b="1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Supplementary</a:t>
            </a:r>
            <a:r>
              <a:rPr lang="de-DE" sz="14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Figure 2: </a:t>
            </a:r>
            <a:r>
              <a:rPr lang="de-DE" sz="1400" b="1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Similar</a:t>
            </a:r>
            <a:r>
              <a:rPr lang="de-DE" sz="14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b="1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JCPyV</a:t>
            </a:r>
            <a:r>
              <a:rPr lang="de-DE" sz="14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b="1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mutation</a:t>
            </a:r>
            <a:r>
              <a:rPr lang="de-DE" sz="14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b="1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profile</a:t>
            </a:r>
            <a:r>
              <a:rPr lang="de-DE" sz="14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in </a:t>
            </a:r>
            <a:r>
              <a:rPr lang="de-DE" sz="1400" b="1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samples</a:t>
            </a:r>
            <a:r>
              <a:rPr lang="de-DE" sz="14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#3 and #7. </a:t>
            </a:r>
            <a:r>
              <a:rPr lang="de-DE" sz="14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IGV </a:t>
            </a:r>
            <a:r>
              <a:rPr lang="de-DE" sz="14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creenshot</a:t>
            </a:r>
            <a:r>
              <a:rPr lang="de-DE" sz="14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howing</a:t>
            </a:r>
            <a:r>
              <a:rPr lang="de-DE" sz="14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JCPyV</a:t>
            </a:r>
            <a:r>
              <a:rPr lang="de-DE" sz="14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lignments</a:t>
            </a:r>
            <a:r>
              <a:rPr lang="de-DE" sz="14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of</a:t>
            </a:r>
            <a:r>
              <a:rPr lang="de-DE" sz="14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reads</a:t>
            </a:r>
            <a:r>
              <a:rPr lang="de-DE" sz="14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derived</a:t>
            </a:r>
            <a:r>
              <a:rPr lang="de-DE" sz="14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from</a:t>
            </a:r>
            <a:r>
              <a:rPr lang="de-DE" sz="14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dirty="0" err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amples</a:t>
            </a:r>
            <a:r>
              <a:rPr lang="de-DE" sz="140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#3 and #7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which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were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sequenced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together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 in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the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 same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run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.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While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the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presence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of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JCPyV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 in sample #3 (PML) was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expected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its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detection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 in sample #7 (HIV1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encephalitis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) was not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anticipated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. The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similar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mutation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profiles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suggest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that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index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 hopping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may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have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caused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the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false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-positive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detection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of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JCPyV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 in sample #7. Follow-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up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immunohistochemistry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 and PCR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tests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 in sample #7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were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both</a:t>
            </a:r>
            <a:r>
              <a:rPr lang="de-DE" sz="1400" dirty="0">
                <a:latin typeface="Calibri" panose="020F0502020204030204" pitchFamily="34" charset="0"/>
                <a:cs typeface="Calibri" panose="020F0502020204030204" pitchFamily="34" charset="0"/>
              </a:rPr>
              <a:t> negative.</a:t>
            </a:r>
          </a:p>
        </p:txBody>
      </p:sp>
      <p:pic>
        <p:nvPicPr>
          <p:cNvPr id="2" name="Grafik 1">
            <a:extLst>
              <a:ext uri="{FF2B5EF4-FFF2-40B4-BE49-F238E27FC236}">
                <a16:creationId xmlns:a16="http://schemas.microsoft.com/office/drawing/2014/main" xmlns="" id="{7E36A461-3342-A543-041E-7C7270C9ED4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05623" y="323012"/>
            <a:ext cx="10190961" cy="5228313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xmlns="" id="{43B02FA8-06F3-656E-8179-A781C549621F}"/>
              </a:ext>
            </a:extLst>
          </p:cNvPr>
          <p:cNvSpPr txBox="1"/>
          <p:nvPr/>
        </p:nvSpPr>
        <p:spPr>
          <a:xfrm rot="16200000">
            <a:off x="53853" y="1453180"/>
            <a:ext cx="17342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sample #7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xmlns="" id="{ACCA8037-60CC-2016-9D5E-ACA547305D17}"/>
              </a:ext>
            </a:extLst>
          </p:cNvPr>
          <p:cNvSpPr txBox="1"/>
          <p:nvPr/>
        </p:nvSpPr>
        <p:spPr>
          <a:xfrm rot="16200000">
            <a:off x="37469" y="3415369"/>
            <a:ext cx="17342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sample #3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xmlns="" id="{A4D2E0AD-2FB0-087E-0A09-93A527D39FBB}"/>
              </a:ext>
            </a:extLst>
          </p:cNvPr>
          <p:cNvSpPr txBox="1"/>
          <p:nvPr/>
        </p:nvSpPr>
        <p:spPr>
          <a:xfrm>
            <a:off x="2010911" y="629567"/>
            <a:ext cx="30074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JC </a:t>
            </a:r>
            <a:r>
              <a:rPr lang="de-DE" sz="1600" dirty="0" err="1"/>
              <a:t>virus</a:t>
            </a:r>
            <a:r>
              <a:rPr lang="de-DE" sz="1600" dirty="0"/>
              <a:t> reference (NC_001699)</a:t>
            </a:r>
          </a:p>
        </p:txBody>
      </p:sp>
      <p:cxnSp>
        <p:nvCxnSpPr>
          <p:cNvPr id="11" name="Gerade Verbindung mit Pfeil 10">
            <a:extLst>
              <a:ext uri="{FF2B5EF4-FFF2-40B4-BE49-F238E27FC236}">
                <a16:creationId xmlns:a16="http://schemas.microsoft.com/office/drawing/2014/main" xmlns="" id="{210F36FE-EFA6-0DAA-7B15-45A3438E4570}"/>
              </a:ext>
            </a:extLst>
          </p:cNvPr>
          <p:cNvCxnSpPr/>
          <p:nvPr/>
        </p:nvCxnSpPr>
        <p:spPr>
          <a:xfrm flipV="1">
            <a:off x="4550980" y="1716521"/>
            <a:ext cx="168166" cy="33633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Gerade Verbindung mit Pfeil 11">
            <a:extLst>
              <a:ext uri="{FF2B5EF4-FFF2-40B4-BE49-F238E27FC236}">
                <a16:creationId xmlns:a16="http://schemas.microsoft.com/office/drawing/2014/main" xmlns="" id="{996D9557-ED4F-2C42-076B-2221BACABD91}"/>
              </a:ext>
            </a:extLst>
          </p:cNvPr>
          <p:cNvCxnSpPr/>
          <p:nvPr/>
        </p:nvCxnSpPr>
        <p:spPr>
          <a:xfrm flipV="1">
            <a:off x="4719146" y="1716521"/>
            <a:ext cx="168166" cy="33633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Gerade Verbindung mit Pfeil 12">
            <a:extLst>
              <a:ext uri="{FF2B5EF4-FFF2-40B4-BE49-F238E27FC236}">
                <a16:creationId xmlns:a16="http://schemas.microsoft.com/office/drawing/2014/main" xmlns="" id="{0CB81BD8-E5F0-E7D1-6742-DEC1F3BB2934}"/>
              </a:ext>
            </a:extLst>
          </p:cNvPr>
          <p:cNvCxnSpPr/>
          <p:nvPr/>
        </p:nvCxnSpPr>
        <p:spPr>
          <a:xfrm flipV="1">
            <a:off x="5538952" y="1795348"/>
            <a:ext cx="168166" cy="33633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Gerade Verbindung mit Pfeil 13">
            <a:extLst>
              <a:ext uri="{FF2B5EF4-FFF2-40B4-BE49-F238E27FC236}">
                <a16:creationId xmlns:a16="http://schemas.microsoft.com/office/drawing/2014/main" xmlns="" id="{2C2B0E40-ECF2-9659-330E-23867E57703A}"/>
              </a:ext>
            </a:extLst>
          </p:cNvPr>
          <p:cNvCxnSpPr/>
          <p:nvPr/>
        </p:nvCxnSpPr>
        <p:spPr>
          <a:xfrm flipV="1">
            <a:off x="6245183" y="1795348"/>
            <a:ext cx="168166" cy="33633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Gerade Verbindung mit Pfeil 14">
            <a:extLst>
              <a:ext uri="{FF2B5EF4-FFF2-40B4-BE49-F238E27FC236}">
                <a16:creationId xmlns:a16="http://schemas.microsoft.com/office/drawing/2014/main" xmlns="" id="{4FF1C0BD-63BC-58F0-5C41-D66540DB056A}"/>
              </a:ext>
            </a:extLst>
          </p:cNvPr>
          <p:cNvCxnSpPr/>
          <p:nvPr/>
        </p:nvCxnSpPr>
        <p:spPr>
          <a:xfrm flipV="1">
            <a:off x="6526924" y="1806013"/>
            <a:ext cx="168166" cy="33633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Gerade Verbindung mit Pfeil 15">
            <a:extLst>
              <a:ext uri="{FF2B5EF4-FFF2-40B4-BE49-F238E27FC236}">
                <a16:creationId xmlns:a16="http://schemas.microsoft.com/office/drawing/2014/main" xmlns="" id="{92923526-9D12-8430-B22A-595AD749D4EE}"/>
              </a:ext>
            </a:extLst>
          </p:cNvPr>
          <p:cNvCxnSpPr/>
          <p:nvPr/>
        </p:nvCxnSpPr>
        <p:spPr>
          <a:xfrm flipV="1">
            <a:off x="7755616" y="1806013"/>
            <a:ext cx="168166" cy="33633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Gerade Verbindung mit Pfeil 16">
            <a:extLst>
              <a:ext uri="{FF2B5EF4-FFF2-40B4-BE49-F238E27FC236}">
                <a16:creationId xmlns:a16="http://schemas.microsoft.com/office/drawing/2014/main" xmlns="" id="{16E9CDA6-63B2-BEF0-E063-8EBA108EC293}"/>
              </a:ext>
            </a:extLst>
          </p:cNvPr>
          <p:cNvCxnSpPr/>
          <p:nvPr/>
        </p:nvCxnSpPr>
        <p:spPr>
          <a:xfrm flipV="1">
            <a:off x="8633230" y="1795347"/>
            <a:ext cx="168166" cy="33633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Gerade Verbindung mit Pfeil 17">
            <a:extLst>
              <a:ext uri="{FF2B5EF4-FFF2-40B4-BE49-F238E27FC236}">
                <a16:creationId xmlns:a16="http://schemas.microsoft.com/office/drawing/2014/main" xmlns="" id="{86CB3FCE-5AFA-B716-223C-A43B65FDC97C}"/>
              </a:ext>
            </a:extLst>
          </p:cNvPr>
          <p:cNvCxnSpPr/>
          <p:nvPr/>
        </p:nvCxnSpPr>
        <p:spPr>
          <a:xfrm flipV="1">
            <a:off x="10705968" y="1637847"/>
            <a:ext cx="168166" cy="33633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302560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63</Words>
  <Application>Microsoft Office PowerPoint</Application>
  <PresentationFormat>Widescreen</PresentationFormat>
  <Paragraphs>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Offic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Christian Thomas</dc:creator>
  <cp:lastModifiedBy>Vijayalakshmi R Rajendran B</cp:lastModifiedBy>
  <cp:revision>9</cp:revision>
  <dcterms:created xsi:type="dcterms:W3CDTF">2024-05-09T19:31:59Z</dcterms:created>
  <dcterms:modified xsi:type="dcterms:W3CDTF">2024-10-04T02:00:27Z</dcterms:modified>
</cp:coreProperties>
</file>